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4634"/>
    <p:restoredTop sz="86353"/>
  </p:normalViewPr>
  <p:slideViewPr>
    <p:cSldViewPr snapToGrid="0" snapToObjects="1">
      <p:cViewPr varScale="1">
        <p:scale>
          <a:sx n="216" d="100"/>
          <a:sy n="216" d="100"/>
        </p:scale>
        <p:origin x="2336" y="176"/>
      </p:cViewPr>
      <p:guideLst/>
    </p:cSldViewPr>
  </p:slideViewPr>
  <p:outlineViewPr>
    <p:cViewPr>
      <p:scale>
        <a:sx n="33" d="100"/>
        <a:sy n="33" d="100"/>
      </p:scale>
      <p:origin x="0" y="0"/>
    </p:cViewPr>
    <p:sldLst>
      <p:sld r:id="rId1" collapse="1"/>
    </p:sldLst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_rels/viewProps.xml.rels><?xml version="1.0" encoding="UTF-8" standalone="yes"?>
<Relationships xmlns="http://schemas.openxmlformats.org/package/2006/relationships"><Relationship Id="rId1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Mike/Downloads/figures/county%20estimate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3236858650100068"/>
          <c:y val="0.2241311410375659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39</c:f>
              <c:strCache>
                <c:ptCount val="1"/>
                <c:pt idx="0">
                  <c:v>Bottineau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73:$J$73</c:f>
                <c:numCache>
                  <c:formatCode>General</c:formatCode>
                  <c:ptCount val="9"/>
                  <c:pt idx="0">
                    <c:v>6.74047140537129E-2</c:v>
                  </c:pt>
                  <c:pt idx="1">
                    <c:v>4.27755485646815E-2</c:v>
                  </c:pt>
                  <c:pt idx="2">
                    <c:v>1.50222092321383E-2</c:v>
                  </c:pt>
                  <c:pt idx="3">
                    <c:v>8.4262742914680694E-2</c:v>
                  </c:pt>
                  <c:pt idx="4">
                    <c:v>5.8591124574905798E-2</c:v>
                  </c:pt>
                  <c:pt idx="5">
                    <c:v>3.7597998188809698E-2</c:v>
                  </c:pt>
                  <c:pt idx="6">
                    <c:v>0.10012488225089899</c:v>
                  </c:pt>
                  <c:pt idx="7">
                    <c:v>5.8248362453710602E-2</c:v>
                  </c:pt>
                  <c:pt idx="8">
                    <c:v>4.32220107194769E-2</c:v>
                  </c:pt>
                </c:numCache>
              </c:numRef>
            </c:plus>
            <c:minus>
              <c:numRef>
                <c:f>'Sheet 1 - county estimates'!$B$73:$J$73</c:f>
                <c:numCache>
                  <c:formatCode>General</c:formatCode>
                  <c:ptCount val="9"/>
                  <c:pt idx="0">
                    <c:v>6.74047140537129E-2</c:v>
                  </c:pt>
                  <c:pt idx="1">
                    <c:v>4.27755485646815E-2</c:v>
                  </c:pt>
                  <c:pt idx="2">
                    <c:v>1.50222092321383E-2</c:v>
                  </c:pt>
                  <c:pt idx="3">
                    <c:v>8.4262742914680694E-2</c:v>
                  </c:pt>
                  <c:pt idx="4">
                    <c:v>5.8591124574905798E-2</c:v>
                  </c:pt>
                  <c:pt idx="5">
                    <c:v>3.7597998188809698E-2</c:v>
                  </c:pt>
                  <c:pt idx="6">
                    <c:v>0.10012488225089899</c:v>
                  </c:pt>
                  <c:pt idx="7">
                    <c:v>5.8248362453710602E-2</c:v>
                  </c:pt>
                  <c:pt idx="8">
                    <c:v>4.32220107194769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38:$J$38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39:$J$39</c:f>
              <c:numCache>
                <c:formatCode>General</c:formatCode>
                <c:ptCount val="9"/>
                <c:pt idx="0">
                  <c:v>0.28995501745419699</c:v>
                </c:pt>
                <c:pt idx="1">
                  <c:v>0.45300783706874398</c:v>
                </c:pt>
                <c:pt idx="2">
                  <c:v>0.55423313183189404</c:v>
                </c:pt>
                <c:pt idx="3">
                  <c:v>0.34134173190288902</c:v>
                </c:pt>
                <c:pt idx="4">
                  <c:v>0.32246179347821202</c:v>
                </c:pt>
                <c:pt idx="5">
                  <c:v>0.53447585769065098</c:v>
                </c:pt>
                <c:pt idx="6">
                  <c:v>0.46934613990017299</c:v>
                </c:pt>
                <c:pt idx="7">
                  <c:v>0.65877062689200105</c:v>
                </c:pt>
                <c:pt idx="8">
                  <c:v>0.72184282983054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32C-4B41-80FD-7C3BA57A951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layout>
        <c:manualLayout>
          <c:xMode val="edge"/>
          <c:yMode val="edge"/>
          <c:x val="0.48609162298785125"/>
          <c:y val="0.3096466624182079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80" b="1" i="0" u="none" strike="noStrike" kern="1200" spc="0" baseline="0">
              <a:solidFill>
                <a:schemeClr val="tx1"/>
              </a:solidFill>
              <a:latin typeface="Calibri" panose="020F0502020204030204" pitchFamily="34" charset="0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Sheet 1 - county estimates'!$A$41</c:f>
              <c:strCache>
                <c:ptCount val="1"/>
                <c:pt idx="0">
                  <c:v>War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Sheet 1 - county estimates'!$B$74:$J$74</c:f>
                <c:numCache>
                  <c:formatCode>General</c:formatCode>
                  <c:ptCount val="9"/>
                  <c:pt idx="0">
                    <c:v>5.0317087331042301E-2</c:v>
                  </c:pt>
                  <c:pt idx="1">
                    <c:v>3.2238021693645501E-2</c:v>
                  </c:pt>
                  <c:pt idx="2">
                    <c:v>1.3313346403403901E-2</c:v>
                  </c:pt>
                  <c:pt idx="3">
                    <c:v>5.9515352931087499E-2</c:v>
                  </c:pt>
                  <c:pt idx="4">
                    <c:v>4.3261236464269999E-2</c:v>
                  </c:pt>
                  <c:pt idx="5">
                    <c:v>2.94711652643272E-2</c:v>
                  </c:pt>
                  <c:pt idx="6">
                    <c:v>6.9639502110137794E-2</c:v>
                  </c:pt>
                  <c:pt idx="7">
                    <c:v>5.0950111094925803E-2</c:v>
                  </c:pt>
                  <c:pt idx="8">
                    <c:v>4.3021597760270598E-2</c:v>
                  </c:pt>
                </c:numCache>
              </c:numRef>
            </c:plus>
            <c:minus>
              <c:numRef>
                <c:f>'Sheet 1 - county estimates'!$B$74:$J$74</c:f>
                <c:numCache>
                  <c:formatCode>General</c:formatCode>
                  <c:ptCount val="9"/>
                  <c:pt idx="0">
                    <c:v>5.0317087331042301E-2</c:v>
                  </c:pt>
                  <c:pt idx="1">
                    <c:v>3.2238021693645501E-2</c:v>
                  </c:pt>
                  <c:pt idx="2">
                    <c:v>1.3313346403403901E-2</c:v>
                  </c:pt>
                  <c:pt idx="3">
                    <c:v>5.9515352931087499E-2</c:v>
                  </c:pt>
                  <c:pt idx="4">
                    <c:v>4.3261236464269999E-2</c:v>
                  </c:pt>
                  <c:pt idx="5">
                    <c:v>2.94711652643272E-2</c:v>
                  </c:pt>
                  <c:pt idx="6">
                    <c:v>6.9639502110137794E-2</c:v>
                  </c:pt>
                  <c:pt idx="7">
                    <c:v>5.0950111094925803E-2</c:v>
                  </c:pt>
                  <c:pt idx="8">
                    <c:v>4.302159776027059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Sheet 1 - county estimates'!$B$40:$J$40</c:f>
              <c:strCache>
                <c:ptCount val="9"/>
                <c:pt idx="0">
                  <c:v>May </c:v>
                </c:pt>
                <c:pt idx="1">
                  <c:v>June    2014</c:v>
                </c:pt>
                <c:pt idx="2">
                  <c:v>July </c:v>
                </c:pt>
                <c:pt idx="3">
                  <c:v>May </c:v>
                </c:pt>
                <c:pt idx="4">
                  <c:v>June    2015</c:v>
                </c:pt>
                <c:pt idx="5">
                  <c:v>July</c:v>
                </c:pt>
                <c:pt idx="6">
                  <c:v>May</c:v>
                </c:pt>
                <c:pt idx="7">
                  <c:v>June    2016</c:v>
                </c:pt>
                <c:pt idx="8">
                  <c:v>July </c:v>
                </c:pt>
              </c:strCache>
            </c:strRef>
          </c:cat>
          <c:val>
            <c:numRef>
              <c:f>'Sheet 1 - county estimates'!$B$41:$J$41</c:f>
              <c:numCache>
                <c:formatCode>General</c:formatCode>
                <c:ptCount val="9"/>
                <c:pt idx="0">
                  <c:v>0.252918396331345</c:v>
                </c:pt>
                <c:pt idx="1">
                  <c:v>0.36917558668349298</c:v>
                </c:pt>
                <c:pt idx="2">
                  <c:v>0.45939680969183</c:v>
                </c:pt>
                <c:pt idx="3">
                  <c:v>0.289122901301816</c:v>
                </c:pt>
                <c:pt idx="4">
                  <c:v>0.26926472735951201</c:v>
                </c:pt>
                <c:pt idx="5">
                  <c:v>0.44330629469672</c:v>
                </c:pt>
                <c:pt idx="6">
                  <c:v>0.37916948513255</c:v>
                </c:pt>
                <c:pt idx="7">
                  <c:v>0.61868003313523201</c:v>
                </c:pt>
                <c:pt idx="8">
                  <c:v>0.697828594826823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091-BB4C-BB41-392D5CF61D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42748320"/>
        <c:axId val="142754552"/>
      </c:barChart>
      <c:catAx>
        <c:axId val="142748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142754552"/>
        <c:crosses val="autoZero"/>
        <c:auto val="1"/>
        <c:lblAlgn val="ctr"/>
        <c:lblOffset val="100"/>
        <c:noMultiLvlLbl val="0"/>
      </c:catAx>
      <c:valAx>
        <c:axId val="142754552"/>
        <c:scaling>
          <c:orientation val="minMax"/>
          <c:max val="1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Calibri" panose="020F0502020204030204" pitchFamily="34" charset="0"/>
                <a:ea typeface="+mn-ea"/>
                <a:cs typeface="+mn-cs"/>
              </a:defRPr>
            </a:pPr>
            <a:endParaRPr lang="en-US"/>
          </a:p>
        </c:txPr>
        <c:crossAx val="142748320"/>
        <c:crosses val="autoZero"/>
        <c:crossBetween val="between"/>
        <c:majorUnit val="0.2"/>
      </c:valAx>
      <c:spPr>
        <a:noFill/>
        <a:ln w="25400"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331B71-F090-F940-A640-FC5F5B64804C}" type="datetimeFigureOut">
              <a:rPr lang="en-US" smtClean="0"/>
              <a:t>4/10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C39CFD-31ED-674E-A6D7-2CBBF38B1CB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15944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C39CFD-31ED-674E-A6D7-2CBBF38B1CB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2580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19581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9520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6270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4255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9783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3385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8108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8304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4488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6425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05083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3C2D06-3DD1-7449-8869-21105D6415A8}" type="datetimeFigureOut">
              <a:rPr lang="en-US" smtClean="0"/>
              <a:t>4/10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7DFFDA-3B4B-4B4D-8128-1E96D5090E0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2633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E8D3ABB7-A2FC-1C47-A6B1-6652B7D3C012}"/>
              </a:ext>
            </a:extLst>
          </p:cNvPr>
          <p:cNvSpPr/>
          <p:nvPr/>
        </p:nvSpPr>
        <p:spPr>
          <a:xfrm>
            <a:off x="2284997" y="5309606"/>
            <a:ext cx="5409832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tabLst>
                <a:tab pos="228600" algn="l"/>
              </a:tabLst>
            </a:pP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3 Figure. Probability of </a:t>
            </a:r>
            <a:r>
              <a:rPr lang="en-US" sz="1200" i="1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. </a:t>
            </a:r>
            <a:r>
              <a:rPr lang="en-US" sz="1200" i="1" dirty="0" err="1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osichella</a:t>
            </a: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biotype 1 occurrence (mean </a:t>
            </a:r>
            <a:r>
              <a:rPr lang="en-US" sz="12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± SE</a:t>
            </a: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) at locations in </a:t>
            </a:r>
            <a:r>
              <a:rPr lang="en-US" sz="1200" dirty="0"/>
              <a:t>Bottineau </a:t>
            </a:r>
            <a:r>
              <a: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A) and Ward (B) county North Dakota in 2014, 2015 and 2016.</a:t>
            </a:r>
            <a:endParaRPr lang="en-US" sz="1400" dirty="0"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86ED6574-6E71-4945-9176-8A865882B878}"/>
              </a:ext>
            </a:extLst>
          </p:cNvPr>
          <p:cNvGrpSpPr/>
          <p:nvPr/>
        </p:nvGrpSpPr>
        <p:grpSpPr>
          <a:xfrm>
            <a:off x="2564251" y="540846"/>
            <a:ext cx="4474297" cy="4695825"/>
            <a:chOff x="2564251" y="540846"/>
            <a:chExt cx="4474297" cy="4695825"/>
          </a:xfrm>
        </p:grpSpPr>
        <p:sp>
          <p:nvSpPr>
            <p:cNvPr id="11" name="Text Box 18">
              <a:extLst>
                <a:ext uri="{FF2B5EF4-FFF2-40B4-BE49-F238E27FC236}">
                  <a16:creationId xmlns:a16="http://schemas.microsoft.com/office/drawing/2014/main" id="{B739D434-6B5C-AE48-8652-C5EA13703E49}"/>
                </a:ext>
              </a:extLst>
            </p:cNvPr>
            <p:cNvSpPr txBox="1"/>
            <p:nvPr/>
          </p:nvSpPr>
          <p:spPr>
            <a:xfrm rot="10800000">
              <a:off x="2564251" y="540846"/>
              <a:ext cx="397669" cy="4695825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eaVert" wrap="square" lIns="68580" tIns="34290" rIns="68580" bIns="3429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200" b="1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Probability of </a:t>
              </a:r>
              <a:r>
                <a:rPr lang="en-US" sz="1200" b="1" i="1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A. </a:t>
              </a:r>
              <a:r>
                <a:rPr lang="en-US" sz="1200" b="1" i="1" dirty="0" err="1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toschiella</a:t>
              </a:r>
              <a:r>
                <a:rPr lang="en-US" sz="1200" b="1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 biotype 1 occurrence (mean </a:t>
              </a:r>
              <a:r>
                <a:rPr lang="en-US" sz="12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± </a:t>
              </a:r>
              <a:r>
                <a:rPr lang="en-US" sz="1200" b="1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SE)</a:t>
              </a:r>
              <a:endParaRPr lang="en-US" sz="1200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 Box 16">
              <a:extLst>
                <a:ext uri="{FF2B5EF4-FFF2-40B4-BE49-F238E27FC236}">
                  <a16:creationId xmlns:a16="http://schemas.microsoft.com/office/drawing/2014/main" id="{309FB0DE-D32E-7F45-9519-7707D20C9089}"/>
                </a:ext>
              </a:extLst>
            </p:cNvPr>
            <p:cNvSpPr txBox="1"/>
            <p:nvPr/>
          </p:nvSpPr>
          <p:spPr>
            <a:xfrm>
              <a:off x="4134165" y="4969495"/>
              <a:ext cx="2067801" cy="267176"/>
            </a:xfrm>
            <a:prstGeom prst="rect">
              <a:avLst/>
            </a:prstGeom>
            <a:solidFill>
              <a:schemeClr val="lt1"/>
            </a:solidFill>
            <a:ln w="6350">
              <a:noFill/>
            </a:ln>
          </p:spPr>
          <p:txBody>
            <a:bodyPr rot="0" spcFirstLastPara="0" vert="horz" wrap="square" lIns="68580" tIns="34290" rIns="68580" bIns="34290" numCol="1" spcCol="0" rtlCol="0" fromWordArt="0" anchor="t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sz="1400" b="1" dirty="0">
                  <a:latin typeface="Calibri" panose="020F0502020204030204" pitchFamily="34" charset="0"/>
                  <a:ea typeface="Times New Roman" panose="02020603050405020304" pitchFamily="18" charset="0"/>
                  <a:cs typeface="Calibri" panose="020F0502020204030204" pitchFamily="34" charset="0"/>
                </a:rPr>
                <a:t>Sample Month and Year</a:t>
              </a:r>
              <a:endParaRPr lang="en-US" sz="1400" dirty="0"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endParaRP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C3DFFFA4-E4EB-2445-9D03-FEBCC83C3DC2}"/>
                </a:ext>
              </a:extLst>
            </p:cNvPr>
            <p:cNvGrpSpPr/>
            <p:nvPr/>
          </p:nvGrpSpPr>
          <p:grpSpPr>
            <a:xfrm>
              <a:off x="2942036" y="947791"/>
              <a:ext cx="4096512" cy="4036132"/>
              <a:chOff x="4909756" y="153937"/>
              <a:chExt cx="4096512" cy="4036132"/>
            </a:xfrm>
          </p:grpSpPr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EF1D01DF-A7D5-4294-80EB-260783DD53C7}"/>
                  </a:ext>
                </a:extLst>
              </p:cNvPr>
              <p:cNvGrpSpPr/>
              <p:nvPr/>
            </p:nvGrpSpPr>
            <p:grpSpPr>
              <a:xfrm>
                <a:off x="4909756" y="153937"/>
                <a:ext cx="4096512" cy="4036132"/>
                <a:chOff x="0" y="0"/>
                <a:chExt cx="6747398" cy="5710109"/>
              </a:xfrm>
            </p:grpSpPr>
            <p:graphicFrame>
              <p:nvGraphicFramePr>
                <p:cNvPr id="22" name="Chart 21">
                  <a:extLst>
                    <a:ext uri="{FF2B5EF4-FFF2-40B4-BE49-F238E27FC236}">
                      <a16:creationId xmlns:a16="http://schemas.microsoft.com/office/drawing/2014/main" id="{D92E66CB-D689-4D31-8D1B-B734ED085FF4}"/>
                    </a:ext>
                  </a:extLst>
                </p:cNvPr>
                <p:cNvGraphicFramePr/>
                <p:nvPr>
                  <p:extLst>
                    <p:ext uri="{D42A27DB-BD31-4B8C-83A1-F6EECF244321}">
                      <p14:modId xmlns:p14="http://schemas.microsoft.com/office/powerpoint/2010/main" val="2009111594"/>
                    </p:ext>
                  </p:extLst>
                </p:nvPr>
              </p:nvGraphicFramePr>
              <p:xfrm>
                <a:off x="1249" y="0"/>
                <a:ext cx="6746149" cy="2894644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graphicFrame>
              <p:nvGraphicFramePr>
                <p:cNvPr id="23" name="Chart 22">
                  <a:extLst>
                    <a:ext uri="{FF2B5EF4-FFF2-40B4-BE49-F238E27FC236}">
                      <a16:creationId xmlns:a16="http://schemas.microsoft.com/office/drawing/2014/main" id="{E639C2AF-734C-47D7-814C-D0DB10B92FAE}"/>
                    </a:ext>
                  </a:extLst>
                </p:cNvPr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308233420"/>
                    </p:ext>
                  </p:extLst>
                </p:nvPr>
              </p:nvGraphicFramePr>
              <p:xfrm>
                <a:off x="0" y="2795054"/>
                <a:ext cx="6746149" cy="2915055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</p:grpSp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C3EAC843-9B5B-334A-AB04-EE59BE5F085B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326870" y="408323"/>
                <a:ext cx="189548" cy="171450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none">
                <a:noAutofit/>
              </a:bodyPr>
              <a:lstStyle/>
              <a:p>
                <a:pPr algn="ctr"/>
                <a:r>
                  <a:rPr lang="en-US" sz="1200" b="1" dirty="0">
                    <a:solidFill>
                      <a:srgbClr val="000000"/>
                    </a:solidFill>
                    <a:latin typeface="Calibri" panose="020F0502020204030204" pitchFamily="34" charset="0"/>
                    <a:ea typeface="PMingLiU" panose="02020500000000000000" pitchFamily="18" charset="-120"/>
                    <a:cs typeface="Calibri" panose="020F0502020204030204" pitchFamily="34" charset="0"/>
                  </a:rPr>
                  <a:t>A</a:t>
                </a:r>
                <a:endParaRPr lang="en-US" sz="1600" dirty="0"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182B0935-9935-B342-BEB1-5B32256CFF9A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5326870" y="2368647"/>
                <a:ext cx="189548" cy="171450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none">
                <a:noAutofit/>
              </a:bodyPr>
              <a:lstStyle/>
              <a:p>
                <a:pPr algn="ctr"/>
                <a:r>
                  <a:rPr lang="en-US" sz="1200" b="1" dirty="0">
                    <a:solidFill>
                      <a:srgbClr val="000000"/>
                    </a:solidFill>
                    <a:latin typeface="Calibri" panose="020F0502020204030204" pitchFamily="34" charset="0"/>
                    <a:ea typeface="PMingLiU" panose="02020500000000000000" pitchFamily="18" charset="-120"/>
                    <a:cs typeface="Calibri" panose="020F0502020204030204" pitchFamily="34" charset="0"/>
                  </a:rPr>
                  <a:t>B</a:t>
                </a:r>
                <a:endParaRPr lang="en-US" sz="1600" dirty="0"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0899289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5</TotalTime>
  <Words>60</Words>
  <Application>Microsoft Macintosh PowerPoint</Application>
  <PresentationFormat>On-screen Show (4:3)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 Smith</dc:creator>
  <cp:lastModifiedBy>Microsoft Office User</cp:lastModifiedBy>
  <cp:revision>15</cp:revision>
  <dcterms:created xsi:type="dcterms:W3CDTF">2019-11-04T20:35:29Z</dcterms:created>
  <dcterms:modified xsi:type="dcterms:W3CDTF">2020-04-10T15:46:46Z</dcterms:modified>
</cp:coreProperties>
</file>